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170" autoAdjust="0"/>
  </p:normalViewPr>
  <p:slideViewPr>
    <p:cSldViewPr>
      <p:cViewPr>
        <p:scale>
          <a:sx n="75" d="100"/>
          <a:sy n="75" d="100"/>
        </p:scale>
        <p:origin x="-172" y="6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F8D2-07D3-48E9-9621-E3043512C7D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8B2FE-6AC8-435C-BA75-F6C8698B96F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F8D2-07D3-48E9-9621-E3043512C7D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8B2FE-6AC8-435C-BA75-F6C8698B96F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F8D2-07D3-48E9-9621-E3043512C7D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8B2FE-6AC8-435C-BA75-F6C8698B96F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F8D2-07D3-48E9-9621-E3043512C7D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8B2FE-6AC8-435C-BA75-F6C8698B96F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F8D2-07D3-48E9-9621-E3043512C7D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8B2FE-6AC8-435C-BA75-F6C8698B96F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F8D2-07D3-48E9-9621-E3043512C7D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8B2FE-6AC8-435C-BA75-F6C8698B96F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F8D2-07D3-48E9-9621-E3043512C7D8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8B2FE-6AC8-435C-BA75-F6C8698B96F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F8D2-07D3-48E9-9621-E3043512C7D8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8B2FE-6AC8-435C-BA75-F6C8698B96F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F8D2-07D3-48E9-9621-E3043512C7D8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8B2FE-6AC8-435C-BA75-F6C8698B96F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F8D2-07D3-48E9-9621-E3043512C7D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8B2FE-6AC8-435C-BA75-F6C8698B96F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F8D2-07D3-48E9-9621-E3043512C7D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8B2FE-6AC8-435C-BA75-F6C8698B96F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43F8D2-07D3-48E9-9621-E3043512C7D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58B2FE-6AC8-435C-BA75-F6C8698B96F9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任意多边形 7"/>
          <p:cNvSpPr/>
          <p:nvPr/>
        </p:nvSpPr>
        <p:spPr>
          <a:xfrm rot="19992833">
            <a:off x="375299" y="4788642"/>
            <a:ext cx="468706" cy="341358"/>
          </a:xfrm>
          <a:custGeom>
            <a:avLst/>
            <a:gdLst>
              <a:gd name="connsiteX0" fmla="*/ 0 w 468706"/>
              <a:gd name="connsiteY0" fmla="*/ 0 h 341358"/>
              <a:gd name="connsiteX1" fmla="*/ 467139 w 468706"/>
              <a:gd name="connsiteY1" fmla="*/ 149087 h 341358"/>
              <a:gd name="connsiteX2" fmla="*/ 159026 w 468706"/>
              <a:gd name="connsiteY2" fmla="*/ 258417 h 341358"/>
              <a:gd name="connsiteX3" fmla="*/ 367747 w 468706"/>
              <a:gd name="connsiteY3" fmla="*/ 337930 h 341358"/>
              <a:gd name="connsiteX4" fmla="*/ 357808 w 468706"/>
              <a:gd name="connsiteY4" fmla="*/ 327991 h 341358"/>
              <a:gd name="connsiteX5" fmla="*/ 357808 w 468706"/>
              <a:gd name="connsiteY5" fmla="*/ 327991 h 341358"/>
              <a:gd name="connsiteX6" fmla="*/ 377687 w 468706"/>
              <a:gd name="connsiteY6" fmla="*/ 327991 h 3413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68706" h="341358">
                <a:moveTo>
                  <a:pt x="0" y="0"/>
                </a:moveTo>
                <a:cubicBezTo>
                  <a:pt x="220317" y="53009"/>
                  <a:pt x="440635" y="106018"/>
                  <a:pt x="467139" y="149087"/>
                </a:cubicBezTo>
                <a:cubicBezTo>
                  <a:pt x="493643" y="192156"/>
                  <a:pt x="175591" y="226943"/>
                  <a:pt x="159026" y="258417"/>
                </a:cubicBezTo>
                <a:cubicBezTo>
                  <a:pt x="142461" y="289891"/>
                  <a:pt x="334617" y="326334"/>
                  <a:pt x="367747" y="337930"/>
                </a:cubicBezTo>
                <a:cubicBezTo>
                  <a:pt x="400877" y="349526"/>
                  <a:pt x="357808" y="327991"/>
                  <a:pt x="357808" y="327991"/>
                </a:cubicBezTo>
                <a:lnTo>
                  <a:pt x="357808" y="327991"/>
                </a:lnTo>
                <a:lnTo>
                  <a:pt x="377687" y="327991"/>
                </a:lnTo>
              </a:path>
            </a:pathLst>
          </a:cu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泪滴形 4"/>
          <p:cNvSpPr/>
          <p:nvPr/>
        </p:nvSpPr>
        <p:spPr>
          <a:xfrm rot="7309730">
            <a:off x="1199732" y="4507010"/>
            <a:ext cx="288032" cy="432048"/>
          </a:xfrm>
          <a:prstGeom prst="teardrop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" name="椭圆 3"/>
          <p:cNvSpPr/>
          <p:nvPr/>
        </p:nvSpPr>
        <p:spPr>
          <a:xfrm>
            <a:off x="755576" y="4797152"/>
            <a:ext cx="1008112" cy="504056"/>
          </a:xfrm>
          <a:prstGeom prst="ellipse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泪滴形 5"/>
          <p:cNvSpPr/>
          <p:nvPr/>
        </p:nvSpPr>
        <p:spPr>
          <a:xfrm rot="9308170">
            <a:off x="1270583" y="4486744"/>
            <a:ext cx="288032" cy="432048"/>
          </a:xfrm>
          <a:prstGeom prst="teardrop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7" name="椭圆 6"/>
          <p:cNvSpPr/>
          <p:nvPr/>
        </p:nvSpPr>
        <p:spPr>
          <a:xfrm>
            <a:off x="1603240" y="4959323"/>
            <a:ext cx="45719" cy="89857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左大括号 8"/>
          <p:cNvSpPr/>
          <p:nvPr/>
        </p:nvSpPr>
        <p:spPr>
          <a:xfrm>
            <a:off x="1763688" y="4120945"/>
            <a:ext cx="504056" cy="1352413"/>
          </a:xfrm>
          <a:prstGeom prst="leftBrac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TextBox 9"/>
          <p:cNvSpPr txBox="1"/>
          <p:nvPr/>
        </p:nvSpPr>
        <p:spPr>
          <a:xfrm>
            <a:off x="2360096" y="3985674"/>
            <a:ext cx="1594087" cy="276999"/>
          </a:xfrm>
          <a:prstGeom prst="rect">
            <a:avLst/>
          </a:prstGeom>
          <a:noFill/>
          <a:ln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ontrol </a:t>
            </a:r>
            <a:r>
              <a:rPr lang="en-US" altLang="zh-CN" sz="1200" dirty="0" smtClean="0"/>
              <a:t>group </a:t>
            </a:r>
            <a:r>
              <a:rPr lang="en-US" altLang="zh-CN" sz="1200" dirty="0" smtClean="0"/>
              <a:t>(n=12)</a:t>
            </a:r>
            <a:endParaRPr lang="zh-CN" altLang="en-US" sz="1200" dirty="0" smtClean="0"/>
          </a:p>
        </p:txBody>
      </p:sp>
      <p:sp>
        <p:nvSpPr>
          <p:cNvPr id="11" name="TextBox 10"/>
          <p:cNvSpPr txBox="1"/>
          <p:nvPr/>
        </p:nvSpPr>
        <p:spPr>
          <a:xfrm>
            <a:off x="2353362" y="4604675"/>
            <a:ext cx="1245272" cy="276999"/>
          </a:xfrm>
          <a:prstGeom prst="rect">
            <a:avLst/>
          </a:prstGeom>
          <a:noFill/>
          <a:ln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DSS group </a:t>
            </a:r>
            <a:r>
              <a:rPr lang="en-US" altLang="zh-CN" sz="1200" dirty="0" smtClean="0"/>
              <a:t>(n=12)</a:t>
            </a:r>
            <a:endParaRPr lang="zh-CN" altLang="en-US" sz="1200" dirty="0" smtClean="0"/>
          </a:p>
        </p:txBody>
      </p:sp>
      <p:sp>
        <p:nvSpPr>
          <p:cNvPr id="12" name="TextBox 11"/>
          <p:cNvSpPr txBox="1"/>
          <p:nvPr/>
        </p:nvSpPr>
        <p:spPr>
          <a:xfrm>
            <a:off x="2373650" y="5207787"/>
            <a:ext cx="1174424" cy="276999"/>
          </a:xfrm>
          <a:prstGeom prst="rect">
            <a:avLst/>
          </a:prstGeom>
          <a:noFill/>
          <a:ln>
            <a:solidFill>
              <a:schemeClr val="tx2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BL group (</a:t>
            </a:r>
            <a:r>
              <a:rPr lang="en-US" altLang="zh-CN" sz="1200" dirty="0" smtClean="0"/>
              <a:t>n=12</a:t>
            </a:r>
            <a:r>
              <a:rPr lang="en-US" altLang="zh-CN" sz="1200" dirty="0"/>
              <a:t>)</a:t>
            </a:r>
            <a:endParaRPr lang="zh-CN" altLang="en-US" sz="1200" dirty="0" smtClean="0"/>
          </a:p>
        </p:txBody>
      </p:sp>
      <p:sp>
        <p:nvSpPr>
          <p:cNvPr id="15" name="下箭头 14"/>
          <p:cNvSpPr/>
          <p:nvPr/>
        </p:nvSpPr>
        <p:spPr>
          <a:xfrm rot="16200000">
            <a:off x="3971576" y="4516544"/>
            <a:ext cx="323123" cy="562434"/>
          </a:xfrm>
          <a:prstGeom prst="downArrow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TextBox 15"/>
          <p:cNvSpPr txBox="1"/>
          <p:nvPr/>
        </p:nvSpPr>
        <p:spPr>
          <a:xfrm>
            <a:off x="4568671" y="4682322"/>
            <a:ext cx="1512168" cy="276999"/>
          </a:xfrm>
          <a:prstGeom prst="rect">
            <a:avLst/>
          </a:prstGeom>
          <a:noFill/>
          <a:ln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Disease activity index</a:t>
            </a:r>
            <a:endParaRPr lang="zh-CN" altLang="en-US" sz="1200" dirty="0" smtClean="0"/>
          </a:p>
        </p:txBody>
      </p:sp>
      <p:sp>
        <p:nvSpPr>
          <p:cNvPr id="17" name="下箭头 16"/>
          <p:cNvSpPr/>
          <p:nvPr/>
        </p:nvSpPr>
        <p:spPr>
          <a:xfrm rot="16200000">
            <a:off x="6516559" y="4539604"/>
            <a:ext cx="323123" cy="562434"/>
          </a:xfrm>
          <a:prstGeom prst="downArrow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泪滴形 17"/>
          <p:cNvSpPr/>
          <p:nvPr/>
        </p:nvSpPr>
        <p:spPr>
          <a:xfrm rot="18737721">
            <a:off x="7246468" y="4230947"/>
            <a:ext cx="369148" cy="345405"/>
          </a:xfrm>
          <a:prstGeom prst="teardrop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TextBox 18"/>
          <p:cNvSpPr txBox="1"/>
          <p:nvPr/>
        </p:nvSpPr>
        <p:spPr>
          <a:xfrm>
            <a:off x="7682998" y="4221088"/>
            <a:ext cx="622636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Blood</a:t>
            </a:r>
            <a:endParaRPr lang="en-US" altLang="zh-CN" sz="1200" dirty="0" smtClean="0"/>
          </a:p>
        </p:txBody>
      </p:sp>
      <p:sp>
        <p:nvSpPr>
          <p:cNvPr id="20" name="圆柱形 19"/>
          <p:cNvSpPr/>
          <p:nvPr/>
        </p:nvSpPr>
        <p:spPr>
          <a:xfrm rot="18399064" flipH="1" flipV="1">
            <a:off x="7331365" y="4754831"/>
            <a:ext cx="211744" cy="455103"/>
          </a:xfrm>
          <a:prstGeom prst="can">
            <a:avLst/>
          </a:prstGeom>
          <a:solidFill>
            <a:schemeClr val="accent6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TextBox 20"/>
          <p:cNvSpPr txBox="1"/>
          <p:nvPr/>
        </p:nvSpPr>
        <p:spPr>
          <a:xfrm>
            <a:off x="7693780" y="4843883"/>
            <a:ext cx="622636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 </a:t>
            </a:r>
            <a:r>
              <a:rPr lang="en-US" altLang="zh-CN" sz="1200" dirty="0" smtClean="0"/>
              <a:t>Stool </a:t>
            </a:r>
            <a:endParaRPr lang="en-US" altLang="zh-CN" sz="1200" dirty="0"/>
          </a:p>
        </p:txBody>
      </p:sp>
      <p:sp>
        <p:nvSpPr>
          <p:cNvPr id="24" name="任意多边形 23"/>
          <p:cNvSpPr/>
          <p:nvPr/>
        </p:nvSpPr>
        <p:spPr>
          <a:xfrm rot="10800000">
            <a:off x="7251104" y="5370327"/>
            <a:ext cx="431894" cy="103030"/>
          </a:xfrm>
          <a:custGeom>
            <a:avLst/>
            <a:gdLst>
              <a:gd name="connsiteX0" fmla="*/ 6415 w 2479158"/>
              <a:gd name="connsiteY0" fmla="*/ 412124 h 412124"/>
              <a:gd name="connsiteX1" fmla="*/ 45051 w 2479158"/>
              <a:gd name="connsiteY1" fmla="*/ 115910 h 412124"/>
              <a:gd name="connsiteX2" fmla="*/ 83688 w 2479158"/>
              <a:gd name="connsiteY2" fmla="*/ 90152 h 412124"/>
              <a:gd name="connsiteX3" fmla="*/ 109446 w 2479158"/>
              <a:gd name="connsiteY3" fmla="*/ 51515 h 412124"/>
              <a:gd name="connsiteX4" fmla="*/ 186719 w 2479158"/>
              <a:gd name="connsiteY4" fmla="*/ 25757 h 412124"/>
              <a:gd name="connsiteX5" fmla="*/ 302629 w 2479158"/>
              <a:gd name="connsiteY5" fmla="*/ 64394 h 412124"/>
              <a:gd name="connsiteX6" fmla="*/ 315508 w 2479158"/>
              <a:gd name="connsiteY6" fmla="*/ 115910 h 412124"/>
              <a:gd name="connsiteX7" fmla="*/ 354144 w 2479158"/>
              <a:gd name="connsiteY7" fmla="*/ 231819 h 412124"/>
              <a:gd name="connsiteX8" fmla="*/ 367023 w 2479158"/>
              <a:gd name="connsiteY8" fmla="*/ 270456 h 412124"/>
              <a:gd name="connsiteX9" fmla="*/ 392781 w 2479158"/>
              <a:gd name="connsiteY9" fmla="*/ 309093 h 412124"/>
              <a:gd name="connsiteX10" fmla="*/ 560206 w 2479158"/>
              <a:gd name="connsiteY10" fmla="*/ 296214 h 412124"/>
              <a:gd name="connsiteX11" fmla="*/ 598843 w 2479158"/>
              <a:gd name="connsiteY11" fmla="*/ 283335 h 412124"/>
              <a:gd name="connsiteX12" fmla="*/ 637479 w 2479158"/>
              <a:gd name="connsiteY12" fmla="*/ 244698 h 412124"/>
              <a:gd name="connsiteX13" fmla="*/ 676116 w 2479158"/>
              <a:gd name="connsiteY13" fmla="*/ 218941 h 412124"/>
              <a:gd name="connsiteX14" fmla="*/ 727631 w 2479158"/>
              <a:gd name="connsiteY14" fmla="*/ 167425 h 412124"/>
              <a:gd name="connsiteX15" fmla="*/ 804905 w 2479158"/>
              <a:gd name="connsiteY15" fmla="*/ 115910 h 412124"/>
              <a:gd name="connsiteX16" fmla="*/ 830662 w 2479158"/>
              <a:gd name="connsiteY16" fmla="*/ 77273 h 412124"/>
              <a:gd name="connsiteX17" fmla="*/ 907936 w 2479158"/>
              <a:gd name="connsiteY17" fmla="*/ 25757 h 412124"/>
              <a:gd name="connsiteX18" fmla="*/ 985209 w 2479158"/>
              <a:gd name="connsiteY18" fmla="*/ 77273 h 412124"/>
              <a:gd name="connsiteX19" fmla="*/ 1023846 w 2479158"/>
              <a:gd name="connsiteY19" fmla="*/ 154546 h 412124"/>
              <a:gd name="connsiteX20" fmla="*/ 1036724 w 2479158"/>
              <a:gd name="connsiteY20" fmla="*/ 193183 h 412124"/>
              <a:gd name="connsiteX21" fmla="*/ 1281423 w 2479158"/>
              <a:gd name="connsiteY21" fmla="*/ 218941 h 412124"/>
              <a:gd name="connsiteX22" fmla="*/ 1332938 w 2479158"/>
              <a:gd name="connsiteY22" fmla="*/ 206062 h 412124"/>
              <a:gd name="connsiteX23" fmla="*/ 1345817 w 2479158"/>
              <a:gd name="connsiteY23" fmla="*/ 167425 h 412124"/>
              <a:gd name="connsiteX24" fmla="*/ 1384454 w 2479158"/>
              <a:gd name="connsiteY24" fmla="*/ 141667 h 412124"/>
              <a:gd name="connsiteX25" fmla="*/ 1435969 w 2479158"/>
              <a:gd name="connsiteY25" fmla="*/ 64394 h 412124"/>
              <a:gd name="connsiteX26" fmla="*/ 1461727 w 2479158"/>
              <a:gd name="connsiteY26" fmla="*/ 25757 h 412124"/>
              <a:gd name="connsiteX27" fmla="*/ 1500364 w 2479158"/>
              <a:gd name="connsiteY27" fmla="*/ 0 h 412124"/>
              <a:gd name="connsiteX28" fmla="*/ 1667789 w 2479158"/>
              <a:gd name="connsiteY28" fmla="*/ 38636 h 412124"/>
              <a:gd name="connsiteX29" fmla="*/ 1706426 w 2479158"/>
              <a:gd name="connsiteY29" fmla="*/ 51515 h 412124"/>
              <a:gd name="connsiteX30" fmla="*/ 1796578 w 2479158"/>
              <a:gd name="connsiteY30" fmla="*/ 167425 h 412124"/>
              <a:gd name="connsiteX31" fmla="*/ 1809457 w 2479158"/>
              <a:gd name="connsiteY31" fmla="*/ 206062 h 412124"/>
              <a:gd name="connsiteX32" fmla="*/ 2479158 w 2479158"/>
              <a:gd name="connsiteY32" fmla="*/ 244698 h 41212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</a:cxnLst>
            <a:rect l="l" t="t" r="r" b="b"/>
            <a:pathLst>
              <a:path w="2479158" h="412124">
                <a:moveTo>
                  <a:pt x="6415" y="412124"/>
                </a:moveTo>
                <a:cubicBezTo>
                  <a:pt x="9333" y="353765"/>
                  <a:pt x="-26461" y="187421"/>
                  <a:pt x="45051" y="115910"/>
                </a:cubicBezTo>
                <a:cubicBezTo>
                  <a:pt x="55996" y="104965"/>
                  <a:pt x="70809" y="98738"/>
                  <a:pt x="83688" y="90152"/>
                </a:cubicBezTo>
                <a:cubicBezTo>
                  <a:pt x="92274" y="77273"/>
                  <a:pt x="96320" y="59719"/>
                  <a:pt x="109446" y="51515"/>
                </a:cubicBezTo>
                <a:cubicBezTo>
                  <a:pt x="132470" y="37125"/>
                  <a:pt x="186719" y="25757"/>
                  <a:pt x="186719" y="25757"/>
                </a:cubicBezTo>
                <a:cubicBezTo>
                  <a:pt x="215612" y="30573"/>
                  <a:pt x="279992" y="30439"/>
                  <a:pt x="302629" y="64394"/>
                </a:cubicBezTo>
                <a:cubicBezTo>
                  <a:pt x="312447" y="79122"/>
                  <a:pt x="310422" y="98956"/>
                  <a:pt x="315508" y="115910"/>
                </a:cubicBezTo>
                <a:cubicBezTo>
                  <a:pt x="315523" y="115962"/>
                  <a:pt x="347696" y="212475"/>
                  <a:pt x="354144" y="231819"/>
                </a:cubicBezTo>
                <a:cubicBezTo>
                  <a:pt x="358437" y="244698"/>
                  <a:pt x="359493" y="259160"/>
                  <a:pt x="367023" y="270456"/>
                </a:cubicBezTo>
                <a:lnTo>
                  <a:pt x="392781" y="309093"/>
                </a:lnTo>
                <a:cubicBezTo>
                  <a:pt x="448589" y="304800"/>
                  <a:pt x="504665" y="303157"/>
                  <a:pt x="560206" y="296214"/>
                </a:cubicBezTo>
                <a:cubicBezTo>
                  <a:pt x="573677" y="294530"/>
                  <a:pt x="587547" y="290865"/>
                  <a:pt x="598843" y="283335"/>
                </a:cubicBezTo>
                <a:cubicBezTo>
                  <a:pt x="613997" y="273232"/>
                  <a:pt x="623487" y="256358"/>
                  <a:pt x="637479" y="244698"/>
                </a:cubicBezTo>
                <a:cubicBezTo>
                  <a:pt x="649370" y="234789"/>
                  <a:pt x="663237" y="227527"/>
                  <a:pt x="676116" y="218941"/>
                </a:cubicBezTo>
                <a:cubicBezTo>
                  <a:pt x="697971" y="153376"/>
                  <a:pt x="671433" y="198646"/>
                  <a:pt x="727631" y="167425"/>
                </a:cubicBezTo>
                <a:cubicBezTo>
                  <a:pt x="754692" y="152391"/>
                  <a:pt x="804905" y="115910"/>
                  <a:pt x="804905" y="115910"/>
                </a:cubicBezTo>
                <a:cubicBezTo>
                  <a:pt x="813491" y="103031"/>
                  <a:pt x="819013" y="87466"/>
                  <a:pt x="830662" y="77273"/>
                </a:cubicBezTo>
                <a:cubicBezTo>
                  <a:pt x="853960" y="56887"/>
                  <a:pt x="907936" y="25757"/>
                  <a:pt x="907936" y="25757"/>
                </a:cubicBezTo>
                <a:cubicBezTo>
                  <a:pt x="933694" y="42929"/>
                  <a:pt x="975420" y="47905"/>
                  <a:pt x="985209" y="77273"/>
                </a:cubicBezTo>
                <a:cubicBezTo>
                  <a:pt x="1002983" y="130594"/>
                  <a:pt x="990557" y="104614"/>
                  <a:pt x="1023846" y="154546"/>
                </a:cubicBezTo>
                <a:cubicBezTo>
                  <a:pt x="1028139" y="167425"/>
                  <a:pt x="1030653" y="181041"/>
                  <a:pt x="1036724" y="193183"/>
                </a:cubicBezTo>
                <a:cubicBezTo>
                  <a:pt x="1086929" y="293594"/>
                  <a:pt x="1123101" y="228253"/>
                  <a:pt x="1281423" y="218941"/>
                </a:cubicBezTo>
                <a:cubicBezTo>
                  <a:pt x="1298595" y="214648"/>
                  <a:pt x="1319117" y="217119"/>
                  <a:pt x="1332938" y="206062"/>
                </a:cubicBezTo>
                <a:cubicBezTo>
                  <a:pt x="1343539" y="197581"/>
                  <a:pt x="1337336" y="178026"/>
                  <a:pt x="1345817" y="167425"/>
                </a:cubicBezTo>
                <a:cubicBezTo>
                  <a:pt x="1355486" y="155338"/>
                  <a:pt x="1371575" y="150253"/>
                  <a:pt x="1384454" y="141667"/>
                </a:cubicBezTo>
                <a:lnTo>
                  <a:pt x="1435969" y="64394"/>
                </a:lnTo>
                <a:cubicBezTo>
                  <a:pt x="1444555" y="51515"/>
                  <a:pt x="1448848" y="34343"/>
                  <a:pt x="1461727" y="25757"/>
                </a:cubicBezTo>
                <a:lnTo>
                  <a:pt x="1500364" y="0"/>
                </a:lnTo>
                <a:cubicBezTo>
                  <a:pt x="1617392" y="16719"/>
                  <a:pt x="1561720" y="3280"/>
                  <a:pt x="1667789" y="38636"/>
                </a:cubicBezTo>
                <a:lnTo>
                  <a:pt x="1706426" y="51515"/>
                </a:lnTo>
                <a:cubicBezTo>
                  <a:pt x="1768044" y="143943"/>
                  <a:pt x="1736051" y="106898"/>
                  <a:pt x="1796578" y="167425"/>
                </a:cubicBezTo>
                <a:cubicBezTo>
                  <a:pt x="1800871" y="180304"/>
                  <a:pt x="1803386" y="193920"/>
                  <a:pt x="1809457" y="206062"/>
                </a:cubicBezTo>
                <a:cubicBezTo>
                  <a:pt x="1918075" y="423294"/>
                  <a:pt x="2321851" y="244698"/>
                  <a:pt x="2479158" y="244698"/>
                </a:cubicBezTo>
              </a:path>
            </a:pathLst>
          </a:custGeom>
          <a:noFill/>
          <a:ln w="57150">
            <a:solidFill>
              <a:schemeClr val="accent6">
                <a:lumMod val="20000"/>
                <a:lumOff val="8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流程图: 顺序访问存储器 24"/>
          <p:cNvSpPr/>
          <p:nvPr/>
        </p:nvSpPr>
        <p:spPr>
          <a:xfrm rot="11018997">
            <a:off x="7252388" y="5411439"/>
            <a:ext cx="108914" cy="246592"/>
          </a:xfrm>
          <a:prstGeom prst="flowChartMagneticTape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5"/>
          <p:cNvSpPr txBox="1"/>
          <p:nvPr/>
        </p:nvSpPr>
        <p:spPr>
          <a:xfrm>
            <a:off x="7668344" y="5312241"/>
            <a:ext cx="622636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 </a:t>
            </a:r>
            <a:r>
              <a:rPr lang="en-US" altLang="zh-CN" sz="1200" dirty="0" smtClean="0"/>
              <a:t>Colitis</a:t>
            </a:r>
            <a:endParaRPr lang="en-US" altLang="zh-CN" sz="1200" dirty="0"/>
          </a:p>
        </p:txBody>
      </p:sp>
      <p:cxnSp>
        <p:nvCxnSpPr>
          <p:cNvPr id="28" name="直接箭头连接符 27"/>
          <p:cNvCxnSpPr/>
          <p:nvPr/>
        </p:nvCxnSpPr>
        <p:spPr>
          <a:xfrm>
            <a:off x="838283" y="2924944"/>
            <a:ext cx="7276623" cy="0"/>
          </a:xfrm>
          <a:prstGeom prst="straightConnector1">
            <a:avLst/>
          </a:prstGeom>
          <a:ln w="57150">
            <a:solidFill>
              <a:schemeClr val="accent6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下箭头 28"/>
          <p:cNvSpPr/>
          <p:nvPr/>
        </p:nvSpPr>
        <p:spPr>
          <a:xfrm>
            <a:off x="2921992" y="2420888"/>
            <a:ext cx="108012" cy="43204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TextBox 29"/>
          <p:cNvSpPr txBox="1"/>
          <p:nvPr/>
        </p:nvSpPr>
        <p:spPr>
          <a:xfrm>
            <a:off x="1283585" y="3068960"/>
            <a:ext cx="685028" cy="276999"/>
          </a:xfrm>
          <a:prstGeom prst="rect">
            <a:avLst/>
          </a:prstGeom>
          <a:noFill/>
          <a:ln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4%DSS</a:t>
            </a:r>
            <a:endParaRPr lang="zh-CN" altLang="en-US" sz="1200" dirty="0" smtClean="0"/>
          </a:p>
        </p:txBody>
      </p:sp>
      <p:sp>
        <p:nvSpPr>
          <p:cNvPr id="31" name="TextBox 30"/>
          <p:cNvSpPr txBox="1"/>
          <p:nvPr/>
        </p:nvSpPr>
        <p:spPr>
          <a:xfrm>
            <a:off x="2687490" y="1988840"/>
            <a:ext cx="685028" cy="276999"/>
          </a:xfrm>
          <a:prstGeom prst="rect">
            <a:avLst/>
          </a:prstGeom>
          <a:noFill/>
          <a:ln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7 day</a:t>
            </a:r>
            <a:endParaRPr lang="zh-CN" altLang="en-US" sz="1200" dirty="0" smtClean="0"/>
          </a:p>
        </p:txBody>
      </p:sp>
      <p:sp>
        <p:nvSpPr>
          <p:cNvPr id="32" name="TextBox 31"/>
          <p:cNvSpPr txBox="1"/>
          <p:nvPr/>
        </p:nvSpPr>
        <p:spPr>
          <a:xfrm>
            <a:off x="7088505" y="1999615"/>
            <a:ext cx="796925" cy="460375"/>
          </a:xfrm>
          <a:prstGeom prst="rect">
            <a:avLst/>
          </a:prstGeom>
          <a:noFill/>
          <a:ln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21 day</a:t>
            </a:r>
            <a:endParaRPr lang="en-US" altLang="zh-CN" sz="1200" dirty="0" smtClean="0"/>
          </a:p>
          <a:p>
            <a:r>
              <a:rPr lang="en-US" altLang="zh-CN" sz="1200" dirty="0" smtClean="0"/>
              <a:t>sacrifice</a:t>
            </a:r>
            <a:endParaRPr lang="en-US" altLang="zh-CN" sz="1200" dirty="0" smtClean="0"/>
          </a:p>
        </p:txBody>
      </p:sp>
      <p:sp>
        <p:nvSpPr>
          <p:cNvPr id="33" name="下箭头 32"/>
          <p:cNvSpPr/>
          <p:nvPr/>
        </p:nvSpPr>
        <p:spPr>
          <a:xfrm>
            <a:off x="7377036" y="2420888"/>
            <a:ext cx="108012" cy="43204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TextBox 33"/>
          <p:cNvSpPr txBox="1"/>
          <p:nvPr/>
        </p:nvSpPr>
        <p:spPr>
          <a:xfrm>
            <a:off x="3556115" y="3068960"/>
            <a:ext cx="3002112" cy="461665"/>
          </a:xfrm>
          <a:prstGeom prst="rect">
            <a:avLst/>
          </a:prstGeom>
          <a:noFill/>
          <a:ln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DSS group</a:t>
            </a:r>
            <a:r>
              <a:rPr lang="en-US" altLang="zh-CN" sz="1200" dirty="0" smtClean="0"/>
              <a:t>: drinking water 14 day</a:t>
            </a:r>
            <a:endParaRPr lang="en-US" altLang="zh-CN" sz="1200" dirty="0" smtClean="0"/>
          </a:p>
          <a:p>
            <a:r>
              <a:rPr lang="en-US" altLang="zh-CN" sz="1200" dirty="0" smtClean="0"/>
              <a:t>BL group: </a:t>
            </a:r>
            <a:r>
              <a:rPr lang="en-US" altLang="zh-CN" sz="1200" dirty="0"/>
              <a:t>Bovine </a:t>
            </a:r>
            <a:r>
              <a:rPr lang="en-US" altLang="zh-CN" sz="1200" dirty="0" err="1"/>
              <a:t>Lactoferrin</a:t>
            </a:r>
            <a:r>
              <a:rPr lang="zh-CN" altLang="en-US" sz="1200" dirty="0"/>
              <a:t>（</a:t>
            </a:r>
            <a:r>
              <a:rPr lang="en-US" altLang="zh-CN" sz="1200" dirty="0"/>
              <a:t>100 mg/kg</a:t>
            </a:r>
            <a:r>
              <a:rPr lang="zh-CN" altLang="en-US" sz="1200" dirty="0" smtClean="0"/>
              <a:t>）</a:t>
            </a:r>
            <a:endParaRPr lang="en-US" altLang="zh-CN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9</Words>
  <Application>WPS 演示</Application>
  <PresentationFormat>全屏显示(4:3)</PresentationFormat>
  <Paragraphs>2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</vt:lpstr>
      <vt:lpstr>SimSun</vt:lpstr>
      <vt:lpstr>Wingdings</vt:lpstr>
      <vt:lpstr>Calibri</vt:lpstr>
      <vt:lpstr>Microsoft YaHei</vt:lpstr>
      <vt:lpstr>Arial Unicode MS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大脸盘子</cp:lastModifiedBy>
  <cp:revision>6</cp:revision>
  <dcterms:created xsi:type="dcterms:W3CDTF">2021-02-24T03:36:00Z</dcterms:created>
  <dcterms:modified xsi:type="dcterms:W3CDTF">2021-02-25T01:19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314</vt:lpwstr>
  </property>
</Properties>
</file>